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4" r:id="rId3"/>
    <p:sldId id="279" r:id="rId4"/>
    <p:sldId id="278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06" autoAdjust="0"/>
    <p:restoredTop sz="94660"/>
  </p:normalViewPr>
  <p:slideViewPr>
    <p:cSldViewPr snapToGrid="0">
      <p:cViewPr varScale="1">
        <p:scale>
          <a:sx n="153" d="100"/>
          <a:sy n="153" d="100"/>
        </p:scale>
        <p:origin x="376" y="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8FC9D2-7F4C-B133-E3F6-CA3615C571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DD4909-AB2F-1EDA-37B8-57959C375A5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984794-B4E8-F383-9E16-D67F80421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1F0CFA-AB8E-1F3B-8F75-58D125BF3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142075-7A5E-8938-C0D2-F088E4FD1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42663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F830CD-7734-12A5-EE90-65E274E622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90EA02-A133-F45C-6CBB-D7C0FBAA04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3F0056-8A36-2E0C-D109-47AFD52FE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0A1918-68A7-A17E-17BB-CC0D9713B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147F93-3278-06C8-97C4-9FF9008BC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63519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85817E-6F92-ABCD-7B7D-98EB1F7A2A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CB754D-DF62-DA74-BCD0-08E4222E37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A3995B-5A56-78E6-A035-282B67AD04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65E528-38E2-4C54-EBA0-690368A49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0258C3-63E0-738A-80D4-35A33C06A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589837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DF3F68-6E26-4701-F9C7-2C93B37B10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5932D4-A1E3-7E75-4412-582D09C681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7D6114-9278-1884-B375-B4410E492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EC5DCE-4DB2-A8BA-F449-A6AFC588C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4E323C-4044-F6A1-BD9C-6A3BA2A1F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96732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7112C-9F46-C16C-4DFF-B9A93273A7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3B0E83-F8E9-15D8-30D7-FF2B2C1509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F810FC-C4F8-E95F-4AB5-16BE3A38C6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1EBA12-D927-1AE7-BEAE-FC8AD22F8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A01907-01ED-9E0B-6E35-4C890756F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41462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B901E3-E57D-030F-3573-BE97ACF3B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E0F9B8-EDE9-3B05-F539-9601C16998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751D61-2276-589F-930F-76D3D03556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6BB4C5-602D-94CC-C0D2-3F45EC7C89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740E96-B30B-35A2-0AFB-67F414612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CD51DB-5FB0-5785-53AE-1C2D90AFC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62527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E5400C-5697-F8CE-EE31-B251A5F1AF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28433A-FDB3-0456-548F-456B4643F0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41C5B9-55EB-7558-F3F7-426A206CB9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4F9D3EE-214C-87B4-E97B-6AE2E210C3F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DCC915-04FB-901A-C618-4DC20FDCF1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70293C-3528-377F-7CFE-F8B35589F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6EE512-481B-0291-3F79-6C05C6852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F9006D-AAF2-4CB8-09B9-CA7B278AB9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45776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533E3-6959-3822-CAA6-763B91B80E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83D749C-325C-1A55-BA6D-F8D29131EE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DD5598-A3C3-25B9-2BBC-844600B14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3449666-81EC-8DEB-50E8-D902E28E8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85152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E1CA74-FFAC-FC06-8BFF-6E6F1009B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3990F67-B951-8C12-3007-7C44B2D73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1D09A68-E481-D4BB-F5F8-16A490990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20386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2EA28-A07A-A063-47D4-F1DB5F66AE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55A22E-3E89-403C-5559-F4025F35EA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7D29D90-3C5C-FE28-DA85-1300FCF98B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54A0F1E-1DE9-CEB3-E5B6-4A9C27138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A2AD68-4770-04CB-E8AA-0B871C1FA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35187F-EE18-1E89-3835-976CC0D354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12471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F771F-3315-83BE-6765-D438C66BA7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68B532-5E36-220C-84E1-12938F3C4F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7CD3B3-74C9-9F17-ED41-8798802E47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8E79DA-1214-A74B-9FC2-67F435974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EE0858-AFA4-133E-DEA0-72C578B2A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7E8769-A01C-A2FA-F537-AEC4F86BD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181418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4B48250-575D-E655-7E70-D1243AAB2D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A15E5C-8128-AAA0-7BF4-3587F29FBE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A312B3-CE48-9173-09CF-F26D5E4C88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4F562-43C5-48B3-A256-10005F154270}" type="datetimeFigureOut">
              <a:rPr lang="en-CA" smtClean="0"/>
              <a:t>2025-04-0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0A2B2C-DD6C-0EAA-FFB3-C310D04A50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9235EE-36C7-671B-98F3-3603F45FF9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B7D71-8A26-4903-BDCB-B510677B7D9C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75440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A0B13E-5F73-B024-5AA7-103BF796B7D6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GB" sz="32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iagnostic Challenges in the Neuropsychology of Epilepsy: Report of the ILAE Neuropsychology Task Force Diagnostic Methods Commission: 2021–2025</a:t>
            </a:r>
            <a:br>
              <a:rPr lang="en-CA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</a:br>
            <a:endParaRPr lang="en-CA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370BB0-335E-0E87-32A1-75AB56DB8DAC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sz="18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ary Lou Smith, Mayu Fujikawa, Genevieve Rayner, Seth A. Margolis, Bruce Hermann, Gus Baker, Sallie Baxendale, Robyn Busch, Aimee Dollman, Vicki Ives-</a:t>
            </a:r>
            <a:r>
              <a:rPr lang="en-GB" sz="1800" kern="100" dirty="0" err="1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eliperi</a:t>
            </a:r>
            <a:r>
              <a:rPr lang="en-GB" sz="1800" kern="100" dirty="0">
                <a:effectLst/>
                <a:latin typeface="Calibri" panose="020F050202020403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, Carrie R. McDonald, Urvashi Shah, Sarah Wilson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407398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1FCCCE3-3F37-6FF1-1D16-CD325CDCE08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9ED94-50F8-C3C2-C085-789310CCA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648463"/>
            <a:ext cx="10515600" cy="1325563"/>
          </a:xfrm>
        </p:spPr>
        <p:txBody>
          <a:bodyPr>
            <a:normAutofit/>
          </a:bodyPr>
          <a:lstStyle/>
          <a:p>
            <a:r>
              <a:rPr lang="en-US" sz="3200" b="1" dirty="0"/>
              <a:t>Neurodevelopmental Issues and Neuropsychological Functioning in Epilepsy</a:t>
            </a:r>
            <a:endParaRPr lang="en-JP" sz="32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147D05-627C-C654-F1BA-6E9C7788CA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108963"/>
            <a:ext cx="10515600" cy="4351338"/>
          </a:xfrm>
        </p:spPr>
        <p:txBody>
          <a:bodyPr>
            <a:norm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dirty="0"/>
              <a:t>The nature of the underlying etiology can affect neuropsychological function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/>
              <a:t>Neurodevelopmental disorders are common in early-onset epilepsy and can affect the developmental trajectory of cognitive function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dirty="0"/>
              <a:t>The effects of chronic epilepsy and the risk of progressive cognitive decline need to be considered as people age.</a:t>
            </a:r>
          </a:p>
        </p:txBody>
      </p:sp>
    </p:spTree>
    <p:extLst>
      <p:ext uri="{BB962C8B-B14F-4D97-AF65-F5344CB8AC3E}">
        <p14:creationId xmlns:p14="http://schemas.microsoft.com/office/powerpoint/2010/main" val="4737778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DAAD0A-3712-0173-9EB5-13D93652F8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648463"/>
            <a:ext cx="10515600" cy="1325563"/>
          </a:xfrm>
        </p:spPr>
        <p:txBody>
          <a:bodyPr>
            <a:normAutofit/>
          </a:bodyPr>
          <a:lstStyle/>
          <a:p>
            <a:r>
              <a:rPr lang="en-US" sz="3200" b="1" dirty="0"/>
              <a:t>Influence of Psychiatric Comorbidities on  Neuropsychological Functioning in Epilepsy</a:t>
            </a:r>
            <a:endParaRPr lang="en-JP" sz="32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0A3D12-8573-CD82-E640-9B06914566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108963"/>
            <a:ext cx="10515600" cy="4351338"/>
          </a:xfrm>
        </p:spPr>
        <p:txBody>
          <a:bodyPr>
            <a:normAutofit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b="0" i="0" dirty="0">
                <a:solidFill>
                  <a:srgbClr val="000000"/>
                </a:solidFill>
                <a:effectLst/>
              </a:rPr>
              <a:t>Psychiatric disorders are common in epilepsy, particularly anxiety, depression, and psychosi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>
                <a:solidFill>
                  <a:srgbClr val="000000"/>
                </a:solidFill>
                <a:effectLst/>
              </a:rPr>
              <a:t>Always ask patients with epilepsy about past and current psychiatric history and symptoms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>
                <a:solidFill>
                  <a:srgbClr val="000000"/>
                </a:solidFill>
                <a:effectLst/>
              </a:rPr>
              <a:t>Psychiatric comorbidities can alter neuropsychological test profile and must be factored into score interpretation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0" i="0" dirty="0">
                <a:solidFill>
                  <a:srgbClr val="000000"/>
                </a:solidFill>
                <a:effectLst/>
              </a:rPr>
              <a:t>Consider: What is the patient likely to experience cognitively because of (</a:t>
            </a:r>
            <a:r>
              <a:rPr lang="en-US" b="0" i="0" dirty="0" err="1">
                <a:solidFill>
                  <a:srgbClr val="000000"/>
                </a:solidFill>
                <a:effectLst/>
              </a:rPr>
              <a:t>i</a:t>
            </a:r>
            <a:r>
              <a:rPr lang="en-US" b="0" i="0" dirty="0">
                <a:solidFill>
                  <a:srgbClr val="000000"/>
                </a:solidFill>
                <a:effectLst/>
              </a:rPr>
              <a:t>) their epilepsy versus (ii) their psychiatric condition?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42377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DAAD0A-3712-0173-9EB5-13D93652F8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648463"/>
            <a:ext cx="10515600" cy="1325563"/>
          </a:xfrm>
        </p:spPr>
        <p:txBody>
          <a:bodyPr>
            <a:normAutofit/>
          </a:bodyPr>
          <a:lstStyle/>
          <a:p>
            <a:r>
              <a:rPr lang="en-US" sz="3200" b="1" dirty="0"/>
              <a:t>Psychosocial Influence on  Neuropsychological Functioning in Epilepsy</a:t>
            </a:r>
            <a:endParaRPr lang="en-JP" sz="32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0A3D12-8573-CD82-E640-9B06914566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108963"/>
            <a:ext cx="10515600" cy="4351338"/>
          </a:xfrm>
        </p:spPr>
        <p:txBody>
          <a:bodyPr>
            <a:normAutofit lnSpcReduction="10000"/>
          </a:bodyPr>
          <a:lstStyle/>
          <a:p>
            <a:pPr>
              <a:buFont typeface="Arial" panose="020B0604020202020204" pitchFamily="34" charset="0"/>
              <a:buChar char="•"/>
            </a:pPr>
            <a:r>
              <a:rPr lang="en-US" b="1" dirty="0"/>
              <a:t>Direct and Indirect Effects:</a:t>
            </a:r>
            <a:r>
              <a:rPr lang="en-US" dirty="0"/>
              <a:t> Psychosocial factors impact cognition and its test performance both directly and indirectly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1" dirty="0"/>
              <a:t>Adjustment: </a:t>
            </a:r>
            <a:r>
              <a:rPr lang="en-US" dirty="0"/>
              <a:t>Difficulty adjusting to epilepsy leads to stress, anxiety, and mood issues, affecting cognition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1" dirty="0"/>
              <a:t>Stigma and Isolation:</a:t>
            </a:r>
            <a:r>
              <a:rPr lang="en-US" dirty="0"/>
              <a:t> Increase anxiety and depression, indirectly affecting cognitive performance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1" dirty="0"/>
              <a:t>Adversity:</a:t>
            </a:r>
            <a:r>
              <a:rPr lang="en-US" dirty="0"/>
              <a:t> Socioeconomic and life stressors influence cognitive abilities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b="1"/>
              <a:t>Cultural and </a:t>
            </a:r>
            <a:r>
              <a:rPr lang="en-US" b="1" dirty="0"/>
              <a:t>Language Diversity:</a:t>
            </a:r>
            <a:r>
              <a:rPr lang="en-US" dirty="0"/>
              <a:t> Affect test selection, interpretation, and performance accuracy.</a:t>
            </a:r>
          </a:p>
        </p:txBody>
      </p:sp>
    </p:spTree>
    <p:extLst>
      <p:ext uri="{BB962C8B-B14F-4D97-AF65-F5344CB8AC3E}">
        <p14:creationId xmlns:p14="http://schemas.microsoft.com/office/powerpoint/2010/main" val="2985148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7</Words>
  <Application>Microsoft Office PowerPoint</Application>
  <PresentationFormat>Widescreen</PresentationFormat>
  <Paragraphs>1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Office Theme</vt:lpstr>
      <vt:lpstr>Diagnostic Challenges in the Neuropsychology of Epilepsy: Report of the ILAE Neuropsychology Task Force Diagnostic Methods Commission: 2021–2025 </vt:lpstr>
      <vt:lpstr>Neurodevelopmental Issues and Neuropsychological Functioning in Epilepsy</vt:lpstr>
      <vt:lpstr>Influence of Psychiatric Comorbidities on  Neuropsychological Functioning in Epilepsy</vt:lpstr>
      <vt:lpstr>Psychosocial Influence on  Neuropsychological Functioning in Epileps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ylou Smith</dc:creator>
  <cp:lastModifiedBy>Marylou Smith</cp:lastModifiedBy>
  <cp:revision>2</cp:revision>
  <dcterms:created xsi:type="dcterms:W3CDTF">2025-04-01T13:39:37Z</dcterms:created>
  <dcterms:modified xsi:type="dcterms:W3CDTF">2025-04-01T15:42:15Z</dcterms:modified>
</cp:coreProperties>
</file>